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notesMasterIdLst>
    <p:notesMasterId r:id="rId19"/>
  </p:notesMasterIdLst>
  <p:sldIdLst>
    <p:sldId id="304" r:id="rId6"/>
    <p:sldId id="296" r:id="rId7"/>
    <p:sldId id="279" r:id="rId8"/>
    <p:sldId id="297" r:id="rId9"/>
    <p:sldId id="257" r:id="rId10"/>
    <p:sldId id="298" r:id="rId11"/>
    <p:sldId id="302" r:id="rId12"/>
    <p:sldId id="300" r:id="rId13"/>
    <p:sldId id="301" r:id="rId14"/>
    <p:sldId id="299" r:id="rId15"/>
    <p:sldId id="294" r:id="rId16"/>
    <p:sldId id="295" r:id="rId17"/>
    <p:sldId id="303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slide" Target="slides/slide13.xml"/><Relationship Id="rId3" Type="http://schemas.openxmlformats.org/officeDocument/2006/relationships/customXml" Target="../customXml/item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customXml" Target="../customXml/item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C8CEA7F-B609-4000-B455-B65E6851D547}" type="doc">
      <dgm:prSet loTypeId="urn:microsoft.com/office/officeart/2005/8/layout/vList2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8553B410-1976-410B-8C82-D3A694DCC788}">
      <dgm:prSet phldrT="[Text]"/>
      <dgm:spPr/>
      <dgm:t>
        <a:bodyPr/>
        <a:lstStyle/>
        <a:p>
          <a:r>
            <a:rPr lang="en-US" dirty="0"/>
            <a:t>The pregnancy is in the uterus</a:t>
          </a:r>
        </a:p>
      </dgm:t>
    </dgm:pt>
    <dgm:pt modelId="{3125B384-40EA-4ED2-8355-A86D6430B9C3}" type="parTrans" cxnId="{AE713902-1DEE-41A1-A988-F2B0C0378BF0}">
      <dgm:prSet/>
      <dgm:spPr/>
      <dgm:t>
        <a:bodyPr/>
        <a:lstStyle/>
        <a:p>
          <a:endParaRPr lang="en-US"/>
        </a:p>
      </dgm:t>
    </dgm:pt>
    <dgm:pt modelId="{248E7ED1-97C9-4099-AADC-06A217D2D7B6}" type="sibTrans" cxnId="{AE713902-1DEE-41A1-A988-F2B0C0378BF0}">
      <dgm:prSet/>
      <dgm:spPr/>
      <dgm:t>
        <a:bodyPr/>
        <a:lstStyle/>
        <a:p>
          <a:endParaRPr lang="en-US"/>
        </a:p>
      </dgm:t>
    </dgm:pt>
    <dgm:pt modelId="{A71C32BB-4C2E-4697-911C-E1C2364E557D}">
      <dgm:prSet phldrT="[Text]"/>
      <dgm:spPr/>
      <dgm:t>
        <a:bodyPr/>
        <a:lstStyle/>
        <a:p>
          <a:r>
            <a:rPr lang="en-US" dirty="0"/>
            <a:t>Ultrasound needs to show at least a gestational sac</a:t>
          </a:r>
        </a:p>
      </dgm:t>
    </dgm:pt>
    <dgm:pt modelId="{4B80EDF9-F9E4-467E-94F1-EF4AC57BD9EA}" type="parTrans" cxnId="{C33C6EBC-190C-4DFD-AB42-FA09B3231D7F}">
      <dgm:prSet/>
      <dgm:spPr/>
      <dgm:t>
        <a:bodyPr/>
        <a:lstStyle/>
        <a:p>
          <a:endParaRPr lang="en-US"/>
        </a:p>
      </dgm:t>
    </dgm:pt>
    <dgm:pt modelId="{598D9C9F-1FA6-4C20-A43C-CEC0993FA240}" type="sibTrans" cxnId="{C33C6EBC-190C-4DFD-AB42-FA09B3231D7F}">
      <dgm:prSet/>
      <dgm:spPr/>
      <dgm:t>
        <a:bodyPr/>
        <a:lstStyle/>
        <a:p>
          <a:endParaRPr lang="en-US"/>
        </a:p>
      </dgm:t>
    </dgm:pt>
    <dgm:pt modelId="{F268AC94-23B2-4803-B35F-41DEC61E625F}">
      <dgm:prSet phldrT="[Text]"/>
      <dgm:spPr/>
      <dgm:t>
        <a:bodyPr/>
        <a:lstStyle/>
        <a:p>
          <a:r>
            <a:rPr lang="en-US" dirty="0"/>
            <a:t>There is a pathway from the endometrial cavity to the vagina</a:t>
          </a:r>
        </a:p>
      </dgm:t>
    </dgm:pt>
    <dgm:pt modelId="{1F61BFA9-80A5-4246-B40B-69C0217E83FB}" type="parTrans" cxnId="{0A88EEE7-28B8-4A5A-88B8-F0E63F648BF5}">
      <dgm:prSet/>
      <dgm:spPr/>
      <dgm:t>
        <a:bodyPr/>
        <a:lstStyle/>
        <a:p>
          <a:endParaRPr lang="en-US"/>
        </a:p>
      </dgm:t>
    </dgm:pt>
    <dgm:pt modelId="{AF7779A2-256F-40AF-8E14-CD4710867E8D}" type="sibTrans" cxnId="{0A88EEE7-28B8-4A5A-88B8-F0E63F648BF5}">
      <dgm:prSet/>
      <dgm:spPr/>
      <dgm:t>
        <a:bodyPr/>
        <a:lstStyle/>
        <a:p>
          <a:endParaRPr lang="en-US"/>
        </a:p>
      </dgm:t>
    </dgm:pt>
    <dgm:pt modelId="{9AD857ED-C38D-427E-9436-863EB1C840B1}">
      <dgm:prSet phldrT="[Text]"/>
      <dgm:spPr/>
      <dgm:t>
        <a:bodyPr/>
        <a:lstStyle/>
        <a:p>
          <a:r>
            <a:rPr lang="en-US" dirty="0"/>
            <a:t>Would not subject patient to an invasive procedure if pregnancy not seen</a:t>
          </a:r>
        </a:p>
      </dgm:t>
    </dgm:pt>
    <dgm:pt modelId="{D6FED6AD-06A6-42ED-81A8-BEEA1C501DBB}" type="parTrans" cxnId="{E4EE874E-351F-4F3B-A69A-7BFCB07D75C2}">
      <dgm:prSet/>
      <dgm:spPr/>
      <dgm:t>
        <a:bodyPr/>
        <a:lstStyle/>
        <a:p>
          <a:endParaRPr lang="en-US"/>
        </a:p>
      </dgm:t>
    </dgm:pt>
    <dgm:pt modelId="{19235B60-44AF-4E2E-BFA8-81534740156B}" type="sibTrans" cxnId="{E4EE874E-351F-4F3B-A69A-7BFCB07D75C2}">
      <dgm:prSet/>
      <dgm:spPr/>
      <dgm:t>
        <a:bodyPr/>
        <a:lstStyle/>
        <a:p>
          <a:endParaRPr lang="en-US"/>
        </a:p>
      </dgm:t>
    </dgm:pt>
    <dgm:pt modelId="{0C6CFDF7-4999-4D5F-9854-19BE9E4927F1}">
      <dgm:prSet phldrT="[Text]"/>
      <dgm:spPr/>
      <dgm:t>
        <a:bodyPr/>
        <a:lstStyle/>
        <a:p>
          <a:r>
            <a:rPr lang="en-US" dirty="0"/>
            <a:t>Large lower uterine segment leiomyomata</a:t>
          </a:r>
        </a:p>
      </dgm:t>
    </dgm:pt>
    <dgm:pt modelId="{185D2176-1AA3-43D3-8179-8A34E6C9194F}" type="parTrans" cxnId="{37F997FF-67DF-483B-A0EC-DBFDA776B26C}">
      <dgm:prSet/>
      <dgm:spPr/>
      <dgm:t>
        <a:bodyPr/>
        <a:lstStyle/>
        <a:p>
          <a:endParaRPr lang="en-US"/>
        </a:p>
      </dgm:t>
    </dgm:pt>
    <dgm:pt modelId="{C99F664A-4BE0-4CD3-96F2-526A58F17150}" type="sibTrans" cxnId="{37F997FF-67DF-483B-A0EC-DBFDA776B26C}">
      <dgm:prSet/>
      <dgm:spPr/>
      <dgm:t>
        <a:bodyPr/>
        <a:lstStyle/>
        <a:p>
          <a:endParaRPr lang="en-US"/>
        </a:p>
      </dgm:t>
    </dgm:pt>
    <dgm:pt modelId="{E8C34271-A7E3-4325-AAC7-31560F3F2A32}">
      <dgm:prSet phldrT="[Text]"/>
      <dgm:spPr/>
      <dgm:t>
        <a:bodyPr/>
        <a:lstStyle/>
        <a:p>
          <a:r>
            <a:rPr lang="en-US" dirty="0"/>
            <a:t>Mullerian anomalies such as a blind horn or uterus didelphys </a:t>
          </a:r>
        </a:p>
      </dgm:t>
    </dgm:pt>
    <dgm:pt modelId="{B30E5ED2-918F-435A-A068-46ECB086EEE0}" type="parTrans" cxnId="{E5EF8153-5037-4BFB-BEFC-BA510E1B2326}">
      <dgm:prSet/>
      <dgm:spPr/>
      <dgm:t>
        <a:bodyPr/>
        <a:lstStyle/>
        <a:p>
          <a:endParaRPr lang="en-US"/>
        </a:p>
      </dgm:t>
    </dgm:pt>
    <dgm:pt modelId="{DA739551-0B34-49F1-B2DF-1C9B2F023013}" type="sibTrans" cxnId="{E5EF8153-5037-4BFB-BEFC-BA510E1B2326}">
      <dgm:prSet/>
      <dgm:spPr/>
      <dgm:t>
        <a:bodyPr/>
        <a:lstStyle/>
        <a:p>
          <a:endParaRPr lang="en-US"/>
        </a:p>
      </dgm:t>
    </dgm:pt>
    <dgm:pt modelId="{478DDB32-8202-4657-A2B1-7CD73DA72F16}" type="pres">
      <dgm:prSet presAssocID="{FC8CEA7F-B609-4000-B455-B65E6851D547}" presName="linear" presStyleCnt="0">
        <dgm:presLayoutVars>
          <dgm:animLvl val="lvl"/>
          <dgm:resizeHandles val="exact"/>
        </dgm:presLayoutVars>
      </dgm:prSet>
      <dgm:spPr/>
    </dgm:pt>
    <dgm:pt modelId="{E09DB92F-A50B-4A3A-8EFE-B7289F680DEF}" type="pres">
      <dgm:prSet presAssocID="{8553B410-1976-410B-8C82-D3A694DCC788}" presName="parentText" presStyleLbl="node1" presStyleIdx="0" presStyleCnt="2">
        <dgm:presLayoutVars>
          <dgm:chMax val="0"/>
          <dgm:bulletEnabled val="1"/>
        </dgm:presLayoutVars>
      </dgm:prSet>
      <dgm:spPr/>
    </dgm:pt>
    <dgm:pt modelId="{48B55430-F68C-48F7-ACCF-B6A60CAA0BEC}" type="pres">
      <dgm:prSet presAssocID="{8553B410-1976-410B-8C82-D3A694DCC788}" presName="childText" presStyleLbl="revTx" presStyleIdx="0" presStyleCnt="2">
        <dgm:presLayoutVars>
          <dgm:bulletEnabled val="1"/>
        </dgm:presLayoutVars>
      </dgm:prSet>
      <dgm:spPr/>
    </dgm:pt>
    <dgm:pt modelId="{7C067923-6233-4E1A-A89B-FD7495D54BA7}" type="pres">
      <dgm:prSet presAssocID="{F268AC94-23B2-4803-B35F-41DEC61E625F}" presName="parentText" presStyleLbl="node1" presStyleIdx="1" presStyleCnt="2">
        <dgm:presLayoutVars>
          <dgm:chMax val="0"/>
          <dgm:bulletEnabled val="1"/>
        </dgm:presLayoutVars>
      </dgm:prSet>
      <dgm:spPr/>
    </dgm:pt>
    <dgm:pt modelId="{E9C5A7E6-D047-4931-B06F-F288B5142382}" type="pres">
      <dgm:prSet presAssocID="{F268AC94-23B2-4803-B35F-41DEC61E625F}" presName="childText" presStyleLbl="revTx" presStyleIdx="1" presStyleCnt="2">
        <dgm:presLayoutVars>
          <dgm:bulletEnabled val="1"/>
        </dgm:presLayoutVars>
      </dgm:prSet>
      <dgm:spPr/>
    </dgm:pt>
  </dgm:ptLst>
  <dgm:cxnLst>
    <dgm:cxn modelId="{AE713902-1DEE-41A1-A988-F2B0C0378BF0}" srcId="{FC8CEA7F-B609-4000-B455-B65E6851D547}" destId="{8553B410-1976-410B-8C82-D3A694DCC788}" srcOrd="0" destOrd="0" parTransId="{3125B384-40EA-4ED2-8355-A86D6430B9C3}" sibTransId="{248E7ED1-97C9-4099-AADC-06A217D2D7B6}"/>
    <dgm:cxn modelId="{16C45E29-A8B9-44FA-88D2-45EA6F9A605C}" type="presOf" srcId="{F268AC94-23B2-4803-B35F-41DEC61E625F}" destId="{7C067923-6233-4E1A-A89B-FD7495D54BA7}" srcOrd="0" destOrd="0" presId="urn:microsoft.com/office/officeart/2005/8/layout/vList2"/>
    <dgm:cxn modelId="{50B9BD30-5D95-4E81-A5FD-FEBCD8D1EFF7}" type="presOf" srcId="{A71C32BB-4C2E-4697-911C-E1C2364E557D}" destId="{48B55430-F68C-48F7-ACCF-B6A60CAA0BEC}" srcOrd="0" destOrd="0" presId="urn:microsoft.com/office/officeart/2005/8/layout/vList2"/>
    <dgm:cxn modelId="{E4EE874E-351F-4F3B-A69A-7BFCB07D75C2}" srcId="{8553B410-1976-410B-8C82-D3A694DCC788}" destId="{9AD857ED-C38D-427E-9436-863EB1C840B1}" srcOrd="1" destOrd="0" parTransId="{D6FED6AD-06A6-42ED-81A8-BEEA1C501DBB}" sibTransId="{19235B60-44AF-4E2E-BFA8-81534740156B}"/>
    <dgm:cxn modelId="{43F85471-B494-422B-8859-B71609E0E07C}" type="presOf" srcId="{E8C34271-A7E3-4325-AAC7-31560F3F2A32}" destId="{E9C5A7E6-D047-4931-B06F-F288B5142382}" srcOrd="0" destOrd="0" presId="urn:microsoft.com/office/officeart/2005/8/layout/vList2"/>
    <dgm:cxn modelId="{E5EF8153-5037-4BFB-BEFC-BA510E1B2326}" srcId="{F268AC94-23B2-4803-B35F-41DEC61E625F}" destId="{E8C34271-A7E3-4325-AAC7-31560F3F2A32}" srcOrd="0" destOrd="0" parTransId="{B30E5ED2-918F-435A-A068-46ECB086EEE0}" sibTransId="{DA739551-0B34-49F1-B2DF-1C9B2F023013}"/>
    <dgm:cxn modelId="{485F7B88-C4F5-4791-BAE8-870D759CFA7A}" type="presOf" srcId="{8553B410-1976-410B-8C82-D3A694DCC788}" destId="{E09DB92F-A50B-4A3A-8EFE-B7289F680DEF}" srcOrd="0" destOrd="0" presId="urn:microsoft.com/office/officeart/2005/8/layout/vList2"/>
    <dgm:cxn modelId="{132842AC-BF60-47AF-A8CA-62F694A44A42}" type="presOf" srcId="{FC8CEA7F-B609-4000-B455-B65E6851D547}" destId="{478DDB32-8202-4657-A2B1-7CD73DA72F16}" srcOrd="0" destOrd="0" presId="urn:microsoft.com/office/officeart/2005/8/layout/vList2"/>
    <dgm:cxn modelId="{C33C6EBC-190C-4DFD-AB42-FA09B3231D7F}" srcId="{8553B410-1976-410B-8C82-D3A694DCC788}" destId="{A71C32BB-4C2E-4697-911C-E1C2364E557D}" srcOrd="0" destOrd="0" parTransId="{4B80EDF9-F9E4-467E-94F1-EF4AC57BD9EA}" sibTransId="{598D9C9F-1FA6-4C20-A43C-CEC0993FA240}"/>
    <dgm:cxn modelId="{43924CDF-815C-4766-B19F-2E198D3A2A6F}" type="presOf" srcId="{0C6CFDF7-4999-4D5F-9854-19BE9E4927F1}" destId="{E9C5A7E6-D047-4931-B06F-F288B5142382}" srcOrd="0" destOrd="1" presId="urn:microsoft.com/office/officeart/2005/8/layout/vList2"/>
    <dgm:cxn modelId="{0A88EEE7-28B8-4A5A-88B8-F0E63F648BF5}" srcId="{FC8CEA7F-B609-4000-B455-B65E6851D547}" destId="{F268AC94-23B2-4803-B35F-41DEC61E625F}" srcOrd="1" destOrd="0" parTransId="{1F61BFA9-80A5-4246-B40B-69C0217E83FB}" sibTransId="{AF7779A2-256F-40AF-8E14-CD4710867E8D}"/>
    <dgm:cxn modelId="{37F997FF-67DF-483B-A0EC-DBFDA776B26C}" srcId="{F268AC94-23B2-4803-B35F-41DEC61E625F}" destId="{0C6CFDF7-4999-4D5F-9854-19BE9E4927F1}" srcOrd="1" destOrd="0" parTransId="{185D2176-1AA3-43D3-8179-8A34E6C9194F}" sibTransId="{C99F664A-4BE0-4CD3-96F2-526A58F17150}"/>
    <dgm:cxn modelId="{1F4BAFFF-CD0F-4A74-8A37-041A7B92E290}" type="presOf" srcId="{9AD857ED-C38D-427E-9436-863EB1C840B1}" destId="{48B55430-F68C-48F7-ACCF-B6A60CAA0BEC}" srcOrd="0" destOrd="1" presId="urn:microsoft.com/office/officeart/2005/8/layout/vList2"/>
    <dgm:cxn modelId="{4D3F1B12-3D90-46FD-8C65-7D38AB38BD1E}" type="presParOf" srcId="{478DDB32-8202-4657-A2B1-7CD73DA72F16}" destId="{E09DB92F-A50B-4A3A-8EFE-B7289F680DEF}" srcOrd="0" destOrd="0" presId="urn:microsoft.com/office/officeart/2005/8/layout/vList2"/>
    <dgm:cxn modelId="{47A42792-7CDD-4170-A976-737B73E0D442}" type="presParOf" srcId="{478DDB32-8202-4657-A2B1-7CD73DA72F16}" destId="{48B55430-F68C-48F7-ACCF-B6A60CAA0BEC}" srcOrd="1" destOrd="0" presId="urn:microsoft.com/office/officeart/2005/8/layout/vList2"/>
    <dgm:cxn modelId="{BA620FAE-BE4B-443C-A0BC-D1DBB8F46650}" type="presParOf" srcId="{478DDB32-8202-4657-A2B1-7CD73DA72F16}" destId="{7C067923-6233-4E1A-A89B-FD7495D54BA7}" srcOrd="2" destOrd="0" presId="urn:microsoft.com/office/officeart/2005/8/layout/vList2"/>
    <dgm:cxn modelId="{5C51266B-C0CC-4252-82B5-7555BCE2D7F5}" type="presParOf" srcId="{478DDB32-8202-4657-A2B1-7CD73DA72F16}" destId="{E9C5A7E6-D047-4931-B06F-F288B5142382}" srcOrd="3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E09DB92F-A50B-4A3A-8EFE-B7289F680DEF}">
      <dsp:nvSpPr>
        <dsp:cNvPr id="0" name=""/>
        <dsp:cNvSpPr/>
      </dsp:nvSpPr>
      <dsp:spPr>
        <a:xfrm>
          <a:off x="0" y="53477"/>
          <a:ext cx="10160000" cy="117877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85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8110" tIns="118110" rIns="118110" bIns="11811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/>
            <a:t>The pregnancy is in the uterus</a:t>
          </a:r>
        </a:p>
      </dsp:txBody>
      <dsp:txXfrm>
        <a:off x="57543" y="111020"/>
        <a:ext cx="10044914" cy="1063689"/>
      </dsp:txXfrm>
    </dsp:sp>
    <dsp:sp modelId="{48B55430-F68C-48F7-ACCF-B6A60CAA0BEC}">
      <dsp:nvSpPr>
        <dsp:cNvPr id="0" name=""/>
        <dsp:cNvSpPr/>
      </dsp:nvSpPr>
      <dsp:spPr>
        <a:xfrm>
          <a:off x="0" y="1232252"/>
          <a:ext cx="10160000" cy="112297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22580" tIns="39370" rIns="220472" bIns="39370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/>
            <a:t>Ultrasound needs to show at least a gestational sac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/>
            <a:t>Would not subject patient to an invasive procedure if pregnancy not seen</a:t>
          </a:r>
        </a:p>
      </dsp:txBody>
      <dsp:txXfrm>
        <a:off x="0" y="1232252"/>
        <a:ext cx="10160000" cy="1122975"/>
      </dsp:txXfrm>
    </dsp:sp>
    <dsp:sp modelId="{7C067923-6233-4E1A-A89B-FD7495D54BA7}">
      <dsp:nvSpPr>
        <dsp:cNvPr id="0" name=""/>
        <dsp:cNvSpPr/>
      </dsp:nvSpPr>
      <dsp:spPr>
        <a:xfrm>
          <a:off x="0" y="2355227"/>
          <a:ext cx="10160000" cy="1178775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8575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8110" tIns="118110" rIns="118110" bIns="118110" numCol="1" spcCol="1270" anchor="ctr" anchorCtr="0">
          <a:noAutofit/>
        </a:bodyPr>
        <a:lstStyle/>
        <a:p>
          <a:pPr marL="0" lvl="0" indent="0" algn="l" defTabSz="1377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100" kern="1200" dirty="0"/>
            <a:t>There is a pathway from the endometrial cavity to the vagina</a:t>
          </a:r>
        </a:p>
      </dsp:txBody>
      <dsp:txXfrm>
        <a:off x="57543" y="2412770"/>
        <a:ext cx="10044914" cy="1063689"/>
      </dsp:txXfrm>
    </dsp:sp>
    <dsp:sp modelId="{E9C5A7E6-D047-4931-B06F-F288B5142382}">
      <dsp:nvSpPr>
        <dsp:cNvPr id="0" name=""/>
        <dsp:cNvSpPr/>
      </dsp:nvSpPr>
      <dsp:spPr>
        <a:xfrm>
          <a:off x="0" y="3534002"/>
          <a:ext cx="10160000" cy="78608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22580" tIns="39370" rIns="220472" bIns="39370" numCol="1" spcCol="1270" anchor="t" anchorCtr="0">
          <a:noAutofit/>
        </a:bodyPr>
        <a:lstStyle/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/>
            <a:t>Mullerian anomalies such as a blind horn or uterus didelphys </a:t>
          </a:r>
        </a:p>
        <a:p>
          <a:pPr marL="228600" lvl="1" indent="-228600" algn="l" defTabSz="1066800">
            <a:lnSpc>
              <a:spcPct val="90000"/>
            </a:lnSpc>
            <a:spcBef>
              <a:spcPct val="0"/>
            </a:spcBef>
            <a:spcAft>
              <a:spcPct val="20000"/>
            </a:spcAft>
            <a:buChar char="•"/>
          </a:pPr>
          <a:r>
            <a:rPr lang="en-US" sz="2400" kern="1200" dirty="0"/>
            <a:t>Large lower uterine segment leiomyomata</a:t>
          </a:r>
        </a:p>
      </dsp:txBody>
      <dsp:txXfrm>
        <a:off x="0" y="3534002"/>
        <a:ext cx="10160000" cy="78608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A88894-786A-4E71-87A1-347990B2ECFC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6707FE-CC34-4782-B81D-243EBF620E3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22231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9A5ECE9-0200-4786-813E-608D195F4FB9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140371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9A5ECE9-0200-4786-813E-608D195F4FB9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99874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ED300-44C8-448E-9613-7D1D0B8AFF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3E556C9-BABC-4778-BB1E-FBCA1B5A65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013531-271B-46D0-BBB8-685D561CE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66B4BE-9A6E-44DC-93AF-25827E52CC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5C7D59-F3F2-4FAC-A4A1-D6D6ADC0B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075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1B3E81-8E7C-4E9D-97BA-53846AD6B2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4A6AC9-4DFF-475D-913E-86B797D3D6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031F2A-41C8-476F-885B-6B2903563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A46DAA-537F-42E4-851D-8BC0C4DCE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C2F394-6BFA-4111-A41F-C8501D1E2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568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07A7A3-12D5-43DD-BB3F-5E612DFF16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30F842-EF3A-4393-BE4F-B61F2B142E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78F501-5CC1-4DE7-A564-8A94E9766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9D835-48DB-4DFA-AA35-7819EAC4B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765D03-3C9F-490C-BE77-48050E5CD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345365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09600" y="228601"/>
            <a:ext cx="10363200" cy="4571999"/>
          </a:xfrm>
        </p:spPr>
        <p:txBody>
          <a:bodyPr anchor="ctr">
            <a:noAutofit/>
          </a:bodyPr>
          <a:lstStyle>
            <a:lvl1pPr>
              <a:lnSpc>
                <a:spcPct val="100000"/>
              </a:lnSpc>
              <a:defRPr sz="8800" spc="-80" baseline="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09600" y="4800600"/>
            <a:ext cx="9144000" cy="914400"/>
          </a:xfrm>
        </p:spPr>
        <p:txBody>
          <a:bodyPr/>
          <a:lstStyle>
            <a:lvl1pPr marL="0" indent="0" algn="l">
              <a:buNone/>
              <a:defRPr b="0" cap="all" spc="120" baseline="0">
                <a:solidFill>
                  <a:schemeClr val="tx2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9C06D-4ED8-42C6-905D-CA84CA1B6CBF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2001499" y="4846320"/>
            <a:ext cx="190501" cy="201168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10" name="Rectangle 9"/>
          <p:cNvSpPr/>
          <p:nvPr/>
        </p:nvSpPr>
        <p:spPr>
          <a:xfrm>
            <a:off x="12001499" y="0"/>
            <a:ext cx="190501" cy="4846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754ED01-E2A0-4C1E-8E21-014B99041579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24067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B1CAA-32CD-4B55-B92A-B8F0843CACF4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459666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1447801"/>
            <a:ext cx="10363200" cy="4321175"/>
          </a:xfrm>
        </p:spPr>
        <p:txBody>
          <a:bodyPr anchor="ctr">
            <a:noAutofit/>
          </a:bodyPr>
          <a:lstStyle>
            <a:lvl1pPr algn="l">
              <a:lnSpc>
                <a:spcPct val="100000"/>
              </a:lnSpc>
              <a:defRPr sz="8800" b="0" cap="all" spc="-80" baseline="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228601"/>
            <a:ext cx="10363200" cy="1066800"/>
          </a:xfrm>
        </p:spPr>
        <p:txBody>
          <a:bodyPr anchor="b"/>
          <a:lstStyle>
            <a:lvl1pPr marL="0" indent="0">
              <a:buNone/>
              <a:defRPr sz="2000" b="0" cap="all" spc="120" baseline="0">
                <a:solidFill>
                  <a:schemeClr val="tx2"/>
                </a:solidFill>
                <a:latin typeface="+mj-lt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8CDC4-3D19-4983-B478-82F6B8E5AB66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725183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74240" y="1574800"/>
            <a:ext cx="438912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86880" y="1574800"/>
            <a:ext cx="438912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B82477-D5D3-4181-8C11-75D0F2433A87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607155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70176" y="1572768"/>
            <a:ext cx="4389120" cy="639762"/>
          </a:xfrm>
        </p:spPr>
        <p:txBody>
          <a:bodyPr anchor="b">
            <a:noAutofit/>
          </a:bodyPr>
          <a:lstStyle>
            <a:lvl1pPr marL="0" indent="0">
              <a:buNone/>
              <a:defRPr sz="1800" b="0" cap="all" spc="100" baseline="0">
                <a:solidFill>
                  <a:schemeClr val="tx1"/>
                </a:solidFill>
                <a:latin typeface="+mj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70176" y="2259366"/>
            <a:ext cx="4389120" cy="38404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90944" y="1572768"/>
            <a:ext cx="4389120" cy="639762"/>
          </a:xfrm>
        </p:spPr>
        <p:txBody>
          <a:bodyPr anchor="b">
            <a:noAutofit/>
          </a:bodyPr>
          <a:lstStyle>
            <a:lvl1pPr marL="0" indent="0">
              <a:buNone/>
              <a:defRPr lang="en-US" sz="1800" b="0" kern="1200" cap="all" spc="100" baseline="0" dirty="0" smtClean="0">
                <a:solidFill>
                  <a:schemeClr val="tx1"/>
                </a:solidFill>
                <a:latin typeface="+mj-lt"/>
                <a:ea typeface="+mn-ea"/>
                <a:cs typeface="+mn-cs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marL="0" lvl="0" indent="0" algn="l" defTabSz="914400" rtl="0" eaLnBrk="1" latinLnBrk="0" hangingPunct="1">
              <a:spcBef>
                <a:spcPct val="20000"/>
              </a:spcBef>
              <a:buFont typeface="Arial" pitchFamily="34" charset="0"/>
              <a:buNone/>
            </a:pPr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90944" y="2259366"/>
            <a:ext cx="4389120" cy="384048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E253B-1893-4367-8BAE-DF4BC10DC578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680474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2300D-25B3-4603-86C9-4CB776489F00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574160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14AD9-FCC8-48B7-B85B-012A91320DFF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04731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1600200"/>
            <a:ext cx="6815667" cy="44805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600200"/>
            <a:ext cx="4011084" cy="4480560"/>
          </a:xfrm>
        </p:spPr>
        <p:txBody>
          <a:bodyPr>
            <a:normAutofit/>
          </a:bodyPr>
          <a:lstStyle>
            <a:lvl1pPr marL="0" indent="0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2DC50-D5DB-4F94-B367-9876CD2C4012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4ED01-E2A0-4C1E-8E21-014B99041579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153953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B8346-E2E8-41D7-8428-7F55E41D7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85287A-7356-48B6-8C90-835BC8D40D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FEDFD0-AE35-4CFF-A29D-CB98B82E60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32789D-B6C9-4A34-916F-E27544240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7498C0-AF45-4FE7-A4AE-EF005669A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775798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2001499" y="4846320"/>
            <a:ext cx="190501" cy="201168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-1" y="0"/>
            <a:ext cx="12001169" cy="4846320"/>
          </a:xfrm>
          <a:solidFill>
            <a:schemeClr val="bg1">
              <a:lumMod val="75000"/>
            </a:schemeClr>
          </a:solidFill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0" y="5715000"/>
            <a:ext cx="10871200" cy="4572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EB412-E790-42EA-81FE-2925D3A43D91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609600" y="4953000"/>
            <a:ext cx="10871200" cy="762000"/>
          </a:xfrm>
        </p:spPr>
        <p:txBody>
          <a:bodyPr anchor="t">
            <a:normAutofit/>
          </a:bodyPr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12001499" y="0"/>
            <a:ext cx="190501" cy="484632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1092485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EEE0E-EDB0-4D84-86B0-50833DF22902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5081807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4372C-B5AB-4C39-B273-B99224EB4DD5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0650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B124B-47B8-4223-9782-A896B9782B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19813F-EE4C-49C3-B108-871FE85178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5C398-004C-47D8-8613-C6075427B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C261D0-2C03-4F1C-AAE1-20B17ACF8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F78B00-CFC0-42E7-8E39-0E523C5E8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0080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ABE88-D341-4434-9711-DDCF5E2BDF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76A1D4-9D07-4E86-8985-BEAEBCE8E3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609F7A-5426-4727-8E38-1F12E040A3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3D182D-0565-403B-AF7B-27F18DDBF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936435-475B-4D33-9E0A-A8276516B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889786-D70E-41B5-AE35-E49306AA5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1395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AB6E1B-8D2D-49B7-B5B3-18B4C4B15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34EE0B-22AF-4D3F-AABF-7F76D1F2E7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A4D138-53EC-4A30-ADF3-4903822A98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8E6FA8-A558-4B08-BCBB-A15203D8CF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3839C-DF83-456A-A21C-8C586746D7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E7473A-8600-41E7-9AA4-6B901B943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8D6AC5-ECC6-4855-8C38-75AB24EF5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9309F5-EE1D-4C85-BDA2-329866A18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8951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A0BD45-2A68-48D7-87EA-1C4E4C49A3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FFCE04-1D53-49D8-A026-61BFE9446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2B69BE-488E-49DD-B735-446E1C4D5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30BCA0-912F-4A8E-AC7E-191238D9B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51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D659BA-DD32-491A-8EA4-02C46612D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384A41B-BAC5-4FC2-A69A-EEF70360F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92EC5B-1CAC-4A9A-BF66-88D4AB2B4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5395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485EE-9CA5-4269-9EEA-7998A6CBD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A5189-365E-4114-8DC5-DB3DE7DA16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B4F5B9-2F4A-4BA6-87CF-0CB777528E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3BE349-9674-44AB-AEF3-901ADCADB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92790B-D8E2-4746-AF1D-C8DE376A9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2A3BD2-B669-43E5-BFF7-72116C8D2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9694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3E91E8-1EDA-4C17-A5B5-21337BDB0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417213-E03B-4275-A12A-9CE3336256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50ED6E4-9497-4A27-92A5-738996A08B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70D500-333F-4746-BB3C-03D0E6320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31A900-96DF-483C-8F46-56FD4701E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7564CF-6A31-4A53-A944-96A973BC4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6845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0ED3A9-E806-4C91-AB34-B29CE18E2D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99EFE0-8F8F-4411-BD6B-995961D152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928EC5-961D-4985-8286-FB4C1CA9F7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9426D-24C8-4DED-834E-C1498CD513BA}" type="datetimeFigureOut">
              <a:rPr lang="en-US" smtClean="0"/>
              <a:t>1/23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3CAB8E-D58F-475D-96CE-EDF4C5F235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FA886-0037-45AF-9E03-1083899DB9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1408F-6D94-462E-9B6C-DC0F2A92434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42915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152718"/>
            <a:ext cx="7721600" cy="13716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752601"/>
            <a:ext cx="10160000" cy="43735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172201"/>
            <a:ext cx="4572000" cy="304800"/>
          </a:xfrm>
          <a:prstGeom prst="rect">
            <a:avLst/>
          </a:prstGeom>
        </p:spPr>
        <p:txBody>
          <a:bodyPr vert="horz" lIns="91440" tIns="45720" rIns="91440" bIns="0" rtlCol="0" anchor="b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fld id="{0B385921-A91A-409C-921C-0E0EC1E750EC}" type="datetime2">
              <a:rPr lang="en-US" smtClean="0"/>
              <a:t>Sunday, January 23, 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9600" y="6492876"/>
            <a:ext cx="4572000" cy="283845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 rot="16200000">
            <a:off x="11189124" y="5824644"/>
            <a:ext cx="131572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 b="1">
                <a:solidFill>
                  <a:schemeClr val="tx2"/>
                </a:solidFill>
              </a:defRPr>
            </a:lvl1pPr>
          </a:lstStyle>
          <a:p>
            <a:fld id="{1789C0F2-17E0-497A-9BBE-0C73201AAFE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2001499" y="0"/>
            <a:ext cx="190501" cy="13716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  <p:sp>
        <p:nvSpPr>
          <p:cNvPr id="8" name="Rectangle 7"/>
          <p:cNvSpPr/>
          <p:nvPr/>
        </p:nvSpPr>
        <p:spPr>
          <a:xfrm>
            <a:off x="12001499" y="1371600"/>
            <a:ext cx="190501" cy="54864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792967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3600" kern="1200" cap="all" spc="-6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spcAft>
          <a:spcPts val="600"/>
        </a:spcAft>
        <a:buFont typeface="Arial" pitchFamily="34" charset="0"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8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Clr>
          <a:schemeClr val="tx2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7.jp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3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E19A2-0E54-4566-8CEC-B3CAD1F5CF6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bortion Techniqu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9D16D4-4395-4B69-85B6-51B077B08EE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Hua Meng, MD</a:t>
            </a:r>
          </a:p>
          <a:p>
            <a:r>
              <a:rPr lang="en-US" dirty="0"/>
              <a:t>Assistant Professor of Clinical Obstetrics &amp; Gynecology</a:t>
            </a:r>
          </a:p>
          <a:p>
            <a:r>
              <a:rPr lang="en-US" dirty="0"/>
              <a:t>Indiana University School of Medicin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851358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65F81E-7B26-4BBA-8CD2-21558BD66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Medical Metho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1513BE-ACF6-4DB0-8B01-75FF499276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4-10 weeks – mifepristone 200 mg, misoprostol 6-48 hours later</a:t>
            </a:r>
          </a:p>
          <a:p>
            <a:r>
              <a:rPr lang="en-US" dirty="0"/>
              <a:t>10 0/7 – 23 6/7 weeks, mifepristone and misoprostol or misoprostol alone</a:t>
            </a:r>
          </a:p>
        </p:txBody>
      </p:sp>
    </p:spTree>
    <p:extLst>
      <p:ext uri="{BB962C8B-B14F-4D97-AF65-F5344CB8AC3E}">
        <p14:creationId xmlns:p14="http://schemas.microsoft.com/office/powerpoint/2010/main" val="31469278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1200" y="152718"/>
            <a:ext cx="8178800" cy="1371600"/>
          </a:xfrm>
        </p:spPr>
        <p:txBody>
          <a:bodyPr/>
          <a:lstStyle/>
          <a:p>
            <a:r>
              <a:rPr lang="en-US" dirty="0"/>
              <a:t>First trimester induced abor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35668" y="1602957"/>
            <a:ext cx="5681133" cy="5029199"/>
          </a:xfrm>
        </p:spPr>
        <p:txBody>
          <a:bodyPr>
            <a:normAutofit lnSpcReduction="10000"/>
          </a:bodyPr>
          <a:lstStyle/>
          <a:p>
            <a:r>
              <a:rPr lang="en-US" b="1" dirty="0"/>
              <a:t>Medication Abortion (up to 10wks0d)</a:t>
            </a:r>
          </a:p>
          <a:p>
            <a:pPr lvl="1"/>
            <a:r>
              <a:rPr lang="en-US" dirty="0"/>
              <a:t>Mifepristone in-office, misoprostol at home</a:t>
            </a:r>
          </a:p>
          <a:p>
            <a:pPr lvl="1"/>
            <a:r>
              <a:rPr lang="en-US" dirty="0"/>
              <a:t>Similar to miscarriage experience</a:t>
            </a:r>
          </a:p>
          <a:p>
            <a:pPr lvl="1"/>
            <a:r>
              <a:rPr lang="en-US" dirty="0"/>
              <a:t>Follow-up 1-2 weeks by bHCG or US</a:t>
            </a:r>
            <a:endParaRPr lang="en-US" b="1" dirty="0"/>
          </a:p>
          <a:p>
            <a:endParaRPr lang="en-US" b="1" dirty="0"/>
          </a:p>
          <a:p>
            <a:r>
              <a:rPr lang="en-US" b="1" dirty="0"/>
              <a:t>Suction Dilation &amp; Curettage (up to 13wks6d)</a:t>
            </a:r>
          </a:p>
          <a:p>
            <a:pPr lvl="1"/>
            <a:r>
              <a:rPr lang="en-US" dirty="0"/>
              <a:t>Fast (&lt;10 minute procedure)</a:t>
            </a:r>
          </a:p>
          <a:p>
            <a:pPr lvl="1"/>
            <a:r>
              <a:rPr lang="en-US" dirty="0"/>
              <a:t>Well-tolerated with or without sedation</a:t>
            </a:r>
          </a:p>
          <a:p>
            <a:endParaRPr lang="en-US" dirty="0"/>
          </a:p>
          <a:p>
            <a:r>
              <a:rPr lang="en-US" dirty="0"/>
              <a:t>Both:</a:t>
            </a:r>
          </a:p>
          <a:p>
            <a:pPr lvl="1"/>
            <a:r>
              <a:rPr lang="en-US" b="0" dirty="0"/>
              <a:t>&lt;&lt;1% risk of complications (bleeding, infection, uterine perforation)</a:t>
            </a:r>
          </a:p>
          <a:p>
            <a:pPr lvl="1"/>
            <a:r>
              <a:rPr lang="en-US" dirty="0"/>
              <a:t>No impact on future fertility</a:t>
            </a:r>
            <a:endParaRPr lang="en-US" b="0" dirty="0"/>
          </a:p>
        </p:txBody>
      </p:sp>
      <p:pic>
        <p:nvPicPr>
          <p:cNvPr id="5122" name="Picture 2" descr="Image result for suction d&amp;c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6801" y="2977039"/>
            <a:ext cx="3032167" cy="3655117"/>
          </a:xfrm>
          <a:prstGeom prst="rect">
            <a:avLst/>
          </a:prstGeom>
          <a:noFill/>
          <a:ln w="19050"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medical_abortion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7068" y="1069556"/>
            <a:ext cx="2302933" cy="16120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1575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3493" y="33705"/>
            <a:ext cx="8599707" cy="1492132"/>
          </a:xfrm>
        </p:spPr>
        <p:txBody>
          <a:bodyPr/>
          <a:lstStyle/>
          <a:p>
            <a:r>
              <a:rPr lang="en-US" dirty="0"/>
              <a:t>Second trimester induced abor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63493" y="1525838"/>
            <a:ext cx="8599706" cy="4959630"/>
          </a:xfrm>
        </p:spPr>
        <p:txBody>
          <a:bodyPr>
            <a:noAutofit/>
          </a:bodyPr>
          <a:lstStyle/>
          <a:p>
            <a:r>
              <a:rPr lang="en-US" b="1" dirty="0"/>
              <a:t>Dilation &amp; Evacuation</a:t>
            </a:r>
          </a:p>
          <a:p>
            <a:pPr lvl="1"/>
            <a:r>
              <a:rPr lang="en-US" dirty="0"/>
              <a:t>May require 2 day procedure (first day laminaria placement, second day D&amp;E)</a:t>
            </a:r>
          </a:p>
          <a:p>
            <a:pPr lvl="1"/>
            <a:r>
              <a:rPr lang="en-US" dirty="0"/>
              <a:t>Well-tolerated with moderate sedation</a:t>
            </a:r>
          </a:p>
          <a:p>
            <a:pPr lvl="1"/>
            <a:r>
              <a:rPr lang="en-US" dirty="0"/>
              <a:t>Risks increase with increasing GA &amp; comorbid conditions (prior CS, abnormal placenta, etc)</a:t>
            </a:r>
          </a:p>
          <a:p>
            <a:endParaRPr lang="en-US" dirty="0"/>
          </a:p>
          <a:p>
            <a:r>
              <a:rPr lang="en-US" dirty="0"/>
              <a:t>Induction of Labor</a:t>
            </a:r>
          </a:p>
          <a:p>
            <a:pPr lvl="1"/>
            <a:r>
              <a:rPr lang="en-US" dirty="0"/>
              <a:t>Unpredictable (most &lt;24hrs, risk of failed IOL)</a:t>
            </a:r>
          </a:p>
          <a:p>
            <a:pPr lvl="1"/>
            <a:r>
              <a:rPr lang="en-US" dirty="0"/>
              <a:t> Awake but pain control/epidural available</a:t>
            </a:r>
          </a:p>
          <a:p>
            <a:pPr lvl="1"/>
            <a:r>
              <a:rPr lang="en-US" i="1" dirty="0"/>
              <a:t>Compared to D&amp;E: </a:t>
            </a:r>
          </a:p>
          <a:p>
            <a:pPr lvl="2"/>
            <a:r>
              <a:rPr lang="en-US" sz="2000" dirty="0"/>
              <a:t>Increased risk of bleeding &amp; infection</a:t>
            </a:r>
          </a:p>
          <a:p>
            <a:pPr lvl="2"/>
            <a:r>
              <a:rPr lang="en-US" sz="2000" dirty="0"/>
              <a:t>20% risk of D&amp;C for retained placenta</a:t>
            </a:r>
          </a:p>
        </p:txBody>
      </p:sp>
    </p:spTree>
    <p:extLst>
      <p:ext uri="{BB962C8B-B14F-4D97-AF65-F5344CB8AC3E}">
        <p14:creationId xmlns:p14="http://schemas.microsoft.com/office/powerpoint/2010/main" val="293809885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BDA548-DAAC-4F8F-86E8-3424756C0A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cap="none" dirty="0"/>
              <a:t>Thank you</a:t>
            </a:r>
          </a:p>
        </p:txBody>
      </p:sp>
    </p:spTree>
    <p:extLst>
      <p:ext uri="{BB962C8B-B14F-4D97-AF65-F5344CB8AC3E}">
        <p14:creationId xmlns:p14="http://schemas.microsoft.com/office/powerpoint/2010/main" val="37379990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33AFBB-A0E9-4149-8D67-386E2B6253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cap="none" dirty="0"/>
              <a:t>None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D1338E-33DC-420B-A620-C8B26929FCE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/>
            <a:r>
              <a:rPr lang="en-US" dirty="0"/>
              <a:t>DISCLOSURES AND CONFLICT OF INTERESTS</a:t>
            </a:r>
          </a:p>
        </p:txBody>
      </p:sp>
    </p:spTree>
    <p:extLst>
      <p:ext uri="{BB962C8B-B14F-4D97-AF65-F5344CB8AC3E}">
        <p14:creationId xmlns:p14="http://schemas.microsoft.com/office/powerpoint/2010/main" val="2843578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1200" y="152718"/>
            <a:ext cx="7620000" cy="1371600"/>
          </a:xfrm>
        </p:spPr>
        <p:txBody>
          <a:bodyPr>
            <a:normAutofit fontScale="90000"/>
          </a:bodyPr>
          <a:lstStyle/>
          <a:p>
            <a:r>
              <a:rPr lang="en-US" dirty="0"/>
              <a:t>Termination of pregnancy aka induced abortion</a:t>
            </a:r>
          </a:p>
        </p:txBody>
      </p:sp>
      <p:pic>
        <p:nvPicPr>
          <p:cNvPr id="4" name="Picture 2" descr="https://www.guttmacher.org/sites/default/files/styles/scale_900x720/public/images/whenwomenhaveabortionsgraph_0.png?itok=b7vUDQzk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59"/>
          <a:stretch/>
        </p:blipFill>
        <p:spPr bwMode="auto">
          <a:xfrm>
            <a:off x="1981200" y="1707875"/>
            <a:ext cx="4856255" cy="4659059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4401" y="2117978"/>
            <a:ext cx="2798376" cy="1979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5238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C8222-62D0-4972-A234-44998E65A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0176" y="246490"/>
            <a:ext cx="5421023" cy="1277828"/>
          </a:xfrm>
        </p:spPr>
        <p:txBody>
          <a:bodyPr/>
          <a:lstStyle/>
          <a:p>
            <a:pPr algn="ctr"/>
            <a:r>
              <a:rPr lang="en-US" cap="none" dirty="0"/>
              <a:t>Prerequisites 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CCD71397-F4D9-4FB8-9B84-9711E89424E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88259605"/>
              </p:ext>
            </p:extLst>
          </p:nvPr>
        </p:nvGraphicFramePr>
        <p:xfrm>
          <a:off x="609600" y="1752600"/>
          <a:ext cx="10160000" cy="43735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40332999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6808CF-141C-4567-BE35-01188711DB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744" y="516835"/>
            <a:ext cx="10010693" cy="5868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33222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B1737-9B69-4CA9-8916-EC3D71951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Surgical Metho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1E77C2-BAF7-4C23-A04C-F2596FB106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4-7 weeks - manual vacuum aspiration with a large syringe and long cannula is commonly used</a:t>
            </a:r>
          </a:p>
          <a:p>
            <a:r>
              <a:rPr lang="en-US" dirty="0"/>
              <a:t>8-14 weeks – manual, but more commonly electrical aspiration used</a:t>
            </a:r>
          </a:p>
          <a:p>
            <a:r>
              <a:rPr lang="en-US" dirty="0"/>
              <a:t>15-16 weeks – electrical aspiration can be used but is more difficult</a:t>
            </a:r>
          </a:p>
          <a:p>
            <a:r>
              <a:rPr lang="en-US" dirty="0"/>
              <a:t>14-24 weeks – Dilation and Evacuation</a:t>
            </a:r>
          </a:p>
        </p:txBody>
      </p:sp>
    </p:spTree>
    <p:extLst>
      <p:ext uri="{BB962C8B-B14F-4D97-AF65-F5344CB8AC3E}">
        <p14:creationId xmlns:p14="http://schemas.microsoft.com/office/powerpoint/2010/main" val="2525502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AF7187-A476-4CA1-A099-BBA7428D8A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ervical Prepar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395202-4FCC-445F-8C67-FCDC5BACEE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echanical dilators – Laminaria, Dilapan-S, rigid metal dilators</a:t>
            </a:r>
          </a:p>
          <a:p>
            <a:r>
              <a:rPr lang="en-US" dirty="0"/>
              <a:t>Medicinal – mifepristone, misoprostol</a:t>
            </a:r>
          </a:p>
        </p:txBody>
      </p:sp>
    </p:spTree>
    <p:extLst>
      <p:ext uri="{BB962C8B-B14F-4D97-AF65-F5344CB8AC3E}">
        <p14:creationId xmlns:p14="http://schemas.microsoft.com/office/powerpoint/2010/main" val="27196622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1C52C28-D8B1-44B8-B0D6-4F9D95F066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93490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6808CF-141C-4567-BE35-01188711DB1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4744" y="516835"/>
            <a:ext cx="10010693" cy="5868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054094"/>
      </p:ext>
    </p:extLst>
  </p:cSld>
  <p:clrMapOvr>
    <a:masterClrMapping/>
  </p:clrMapOvr>
</p:sld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Essential">
  <a:themeElements>
    <a:clrScheme name="Essential">
      <a:dk1>
        <a:srgbClr val="000000"/>
      </a:dk1>
      <a:lt1>
        <a:srgbClr val="FFFFFF"/>
      </a:lt1>
      <a:dk2>
        <a:srgbClr val="D1282E"/>
      </a:dk2>
      <a:lt2>
        <a:srgbClr val="C8C8B1"/>
      </a:lt2>
      <a:accent1>
        <a:srgbClr val="7A7A7A"/>
      </a:accent1>
      <a:accent2>
        <a:srgbClr val="F5C201"/>
      </a:accent2>
      <a:accent3>
        <a:srgbClr val="526DB0"/>
      </a:accent3>
      <a:accent4>
        <a:srgbClr val="989AAC"/>
      </a:accent4>
      <a:accent5>
        <a:srgbClr val="DC5924"/>
      </a:accent5>
      <a:accent6>
        <a:srgbClr val="B4B392"/>
      </a:accent6>
      <a:hlink>
        <a:srgbClr val="CC9900"/>
      </a:hlink>
      <a:folHlink>
        <a:srgbClr val="969696"/>
      </a:folHlink>
    </a:clrScheme>
    <a:fontScheme name="Essential">
      <a:majorFont>
        <a:latin typeface="Arial Black"/>
        <a:ea typeface=""/>
        <a:cs typeface=""/>
        <a:font script="Jpan" typeface="ＭＳ Ｐゴシック"/>
        <a:font script="Hang" typeface="HY견고딕"/>
        <a:font script="Hans" typeface="微软雅黑"/>
        <a:font script="Hant" typeface="微軟正黑體"/>
        <a:font script="Arab" typeface="Tahoma"/>
        <a:font script="Hebr" typeface="Tahoma"/>
        <a:font script="Thai" typeface="Tahoma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sential">
      <a:fillStyleLst>
        <a:solidFill>
          <a:schemeClr val="phClr"/>
        </a:solidFill>
        <a:gradFill rotWithShape="1">
          <a:gsLst>
            <a:gs pos="0">
              <a:schemeClr val="phClr">
                <a:tint val="60000"/>
                <a:satMod val="250000"/>
              </a:schemeClr>
            </a:gs>
            <a:gs pos="35000">
              <a:schemeClr val="phClr">
                <a:tint val="47000"/>
                <a:satMod val="275000"/>
              </a:schemeClr>
            </a:gs>
            <a:gs pos="100000">
              <a:schemeClr val="phClr">
                <a:tint val="25000"/>
                <a:satMod val="300000"/>
              </a:schemeClr>
            </a:gs>
          </a:gsLst>
          <a:lin ang="16200000" scaled="1"/>
        </a:gradFill>
        <a:solidFill>
          <a:schemeClr val="phClr">
            <a:satMod val="110000"/>
          </a:schemeClr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8575" cap="flat" cmpd="sng" algn="ctr">
          <a:solidFill>
            <a:schemeClr val="phClr"/>
          </a:solidFill>
          <a:prstDash val="solid"/>
        </a:ln>
        <a:ln w="4127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9999" dist="23000" algn="bl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38100" dist="19050" algn="bl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l"/>
          </a:scene3d>
          <a:sp3d prstMaterial="plastic">
            <a:bevelT w="38100" h="31750"/>
          </a:sp3d>
        </a:effectStyle>
      </a:effectStyleLst>
      <a:bgFillStyleLst>
        <a:solidFill>
          <a:schemeClr val="phClr"/>
        </a:solidFill>
        <a:blipFill rotWithShape="1">
          <a:blip xmlns:r="http://schemas.openxmlformats.org/officeDocument/2006/relationships" r:embed="rId1">
            <a:duotone>
              <a:schemeClr val="phClr">
                <a:tint val="96000"/>
              </a:schemeClr>
              <a:schemeClr val="phClr">
                <a:shade val="94000"/>
              </a:schemeClr>
            </a:duotone>
          </a:blip>
          <a:tile tx="0" ty="0" sx="100000" sy="100000" flip="none" algn="tl"/>
        </a:blipFill>
        <a:gradFill rotWithShape="1">
          <a:gsLst>
            <a:gs pos="0">
              <a:schemeClr val="phClr">
                <a:tint val="84000"/>
                <a:satMod val="110000"/>
              </a:schemeClr>
            </a:gs>
            <a:gs pos="44000">
              <a:schemeClr val="phClr">
                <a:tint val="93000"/>
                <a:satMod val="115000"/>
              </a:schemeClr>
            </a:gs>
            <a:gs pos="100000">
              <a:schemeClr val="phClr">
                <a:tint val="100000"/>
                <a:shade val="59000"/>
                <a:satMod val="120000"/>
              </a:schemeClr>
            </a:gs>
          </a:gsLst>
          <a:path path="circle">
            <a:fillToRect l="40000" t="60000" r="60000" b="4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723FC89C070FC48819A8A579086F135" ma:contentTypeVersion="10" ma:contentTypeDescription="Create a new document." ma:contentTypeScope="" ma:versionID="5d88cd3cac110f8fb5547a74668823a2">
  <xsd:schema xmlns:xsd="http://www.w3.org/2001/XMLSchema" xmlns:xs="http://www.w3.org/2001/XMLSchema" xmlns:p="http://schemas.microsoft.com/office/2006/metadata/properties" xmlns:ns3="dafce31f-2301-42ab-8620-f34602729e68" targetNamespace="http://schemas.microsoft.com/office/2006/metadata/properties" ma:root="true" ma:fieldsID="81447d521e37751a120417561d0f617f" ns3:_="">
    <xsd:import namespace="dafce31f-2301-42ab-8620-f34602729e6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afce31f-2301-42ab-8620-f34602729e6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0D7C45A-264E-4B90-8F57-9612E2D72284}">
  <ds:schemaRefs>
    <ds:schemaRef ds:uri="http://schemas.microsoft.com/office/2006/documentManagement/types"/>
    <ds:schemaRef ds:uri="http://purl.org/dc/elements/1.1/"/>
    <ds:schemaRef ds:uri="http://purl.org/dc/terms/"/>
    <ds:schemaRef ds:uri="http://schemas.openxmlformats.org/package/2006/metadata/core-properties"/>
    <ds:schemaRef ds:uri="http://purl.org/dc/dcmitype/"/>
    <ds:schemaRef ds:uri="dafce31f-2301-42ab-8620-f34602729e68"/>
    <ds:schemaRef ds:uri="http://schemas.microsoft.com/office/infopath/2007/PartnerControls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ED8FDD4-B251-45FD-B0FF-320F68EAEB4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60F146E-2FE0-4BB2-ADB8-D41E7E88A31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afce31f-2301-42ab-8620-f34602729e6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4</TotalTime>
  <Words>336</Words>
  <Application>Microsoft Office PowerPoint</Application>
  <PresentationFormat>Widescreen</PresentationFormat>
  <Paragraphs>53</Paragraphs>
  <Slides>1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3</vt:i4>
      </vt:variant>
    </vt:vector>
  </HeadingPairs>
  <TitlesOfParts>
    <vt:vector size="19" baseType="lpstr">
      <vt:lpstr>Arial</vt:lpstr>
      <vt:lpstr>Arial Black</vt:lpstr>
      <vt:lpstr>Calibri</vt:lpstr>
      <vt:lpstr>Calibri Light</vt:lpstr>
      <vt:lpstr>Office Theme</vt:lpstr>
      <vt:lpstr>Essential</vt:lpstr>
      <vt:lpstr>Abortion Techniques</vt:lpstr>
      <vt:lpstr>None</vt:lpstr>
      <vt:lpstr>Termination of pregnancy aka induced abortion</vt:lpstr>
      <vt:lpstr>Prerequisites </vt:lpstr>
      <vt:lpstr>PowerPoint Presentation</vt:lpstr>
      <vt:lpstr>Surgical Methods</vt:lpstr>
      <vt:lpstr>Cervical Preparation</vt:lpstr>
      <vt:lpstr>PowerPoint Presentation</vt:lpstr>
      <vt:lpstr>PowerPoint Presentation</vt:lpstr>
      <vt:lpstr>Medical Methods</vt:lpstr>
      <vt:lpstr>First trimester induced abortion</vt:lpstr>
      <vt:lpstr>Second trimester induced abortion</vt:lpstr>
      <vt:lpstr>Thank yo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ortion Techniques</dc:title>
  <dc:creator>Meng, Hua</dc:creator>
  <cp:lastModifiedBy>Stout, Julianne</cp:lastModifiedBy>
  <cp:revision>14</cp:revision>
  <dcterms:created xsi:type="dcterms:W3CDTF">2022-01-21T23:58:35Z</dcterms:created>
  <dcterms:modified xsi:type="dcterms:W3CDTF">2022-01-23T16:43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723FC89C070FC48819A8A579086F135</vt:lpwstr>
  </property>
</Properties>
</file>